
<file path=[Content_Types].xml><?xml version="1.0" encoding="utf-8"?>
<Types xmlns="http://schemas.openxmlformats.org/package/2006/content-types"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58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709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992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jpg"/><Relationship Id="rId5" Type="http://schemas.openxmlformats.org/officeDocument/2006/relationships/image" Target="../media/image2.jpg"/><Relationship Id="rId4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2e1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0A1AB74-33AF-FD4D-9A06-B54E93DB0D41}"/>
              </a:ext>
            </a:extLst>
          </p:cNvPr>
          <p:cNvSpPr/>
          <p:nvPr/>
        </p:nvSpPr>
        <p:spPr>
          <a:xfrm>
            <a:off x="1" y="-18901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e1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図 4" descr="BF223_8bit.tif">
            <a:extLst>
              <a:ext uri="{FF2B5EF4-FFF2-40B4-BE49-F238E27FC236}">
                <a16:creationId xmlns:a16="http://schemas.microsoft.com/office/drawing/2014/main" id="{531AFDC5-0EC7-3E47-9C8B-8F623A414E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4098" y="1213695"/>
            <a:ext cx="3233990" cy="3233990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4B471F1-0390-7348-B039-3251A12F3B50}"/>
              </a:ext>
            </a:extLst>
          </p:cNvPr>
          <p:cNvSpPr/>
          <p:nvPr/>
        </p:nvSpPr>
        <p:spPr>
          <a:xfrm>
            <a:off x="3640631" y="623176"/>
            <a:ext cx="28015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Time lapse microscopy of </a:t>
            </a:r>
            <a:r>
              <a:rPr lang="ja-JP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B280993-CD51-4749-92BF-4FAB47A41B6A}"/>
              </a:ext>
            </a:extLst>
          </p:cNvPr>
          <p:cNvSpPr txBox="1"/>
          <p:nvPr/>
        </p:nvSpPr>
        <p:spPr>
          <a:xfrm>
            <a:off x="942441" y="830997"/>
            <a:ext cx="17491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contrast OM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0A41D2A-4290-DB4C-84A4-B985F7C677E8}"/>
              </a:ext>
            </a:extLst>
          </p:cNvPr>
          <p:cNvSpPr txBox="1"/>
          <p:nvPr/>
        </p:nvSpPr>
        <p:spPr>
          <a:xfrm>
            <a:off x="1425071" y="4791075"/>
            <a:ext cx="796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erge</a:t>
            </a:r>
            <a:endParaRPr kumimoji="1" lang="ja-JP" altLang="en-US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36A42B65-62CE-EB47-99FF-DA3E1D897A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098" y="5129629"/>
            <a:ext cx="3236873" cy="3236873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29FEFF6-50C5-4C4C-AF74-8FA2501D59FE}"/>
              </a:ext>
            </a:extLst>
          </p:cNvPr>
          <p:cNvSpPr/>
          <p:nvPr/>
        </p:nvSpPr>
        <p:spPr>
          <a:xfrm>
            <a:off x="3328957" y="4781771"/>
            <a:ext cx="35745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Representation of cell track by color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9C5A8BA9-5268-2145-B614-5AECED55E718}"/>
              </a:ext>
            </a:extLst>
          </p:cNvPr>
          <p:cNvSpPr/>
          <p:nvPr/>
        </p:nvSpPr>
        <p:spPr>
          <a:xfrm>
            <a:off x="5193638" y="8374761"/>
            <a:ext cx="100026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lue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8F2A9112-A1E4-8B4E-9E14-C705BA38D566}"/>
              </a:ext>
            </a:extLst>
          </p:cNvPr>
          <p:cNvCxnSpPr>
            <a:cxnSpLocks/>
          </p:cNvCxnSpPr>
          <p:nvPr/>
        </p:nvCxnSpPr>
        <p:spPr>
          <a:xfrm>
            <a:off x="5001495" y="8574742"/>
            <a:ext cx="35657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FD25EB03-BB2A-B141-A86E-A0A59D100124}"/>
              </a:ext>
            </a:extLst>
          </p:cNvPr>
          <p:cNvSpPr/>
          <p:nvPr/>
        </p:nvSpPr>
        <p:spPr>
          <a:xfrm>
            <a:off x="4159654" y="8374761"/>
            <a:ext cx="100026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Red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FE9C3FD3-3064-E246-92DE-355257C533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95868" y="5127653"/>
            <a:ext cx="3236874" cy="3236873"/>
          </a:xfrm>
          <a:prstGeom prst="rect">
            <a:avLst/>
          </a:prstGeom>
          <a:ln>
            <a:noFill/>
          </a:ln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DBC7676-6257-994D-818A-F6F39AC1F72C}"/>
              </a:ext>
            </a:extLst>
          </p:cNvPr>
          <p:cNvSpPr txBox="1"/>
          <p:nvPr/>
        </p:nvSpPr>
        <p:spPr>
          <a:xfrm>
            <a:off x="4727694" y="870277"/>
            <a:ext cx="7095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Movie</a:t>
            </a:r>
            <a:endParaRPr kumimoji="1" lang="ja-JP" altLang="en-US" sz="1600"/>
          </a:p>
        </p:txBody>
      </p:sp>
      <p:pic>
        <p:nvPicPr>
          <p:cNvPr id="7" name="オンライン メディア 6" descr="S2e右上(2)">
            <a:hlinkClick r:id="" action="ppaction://media"/>
            <a:extLst>
              <a:ext uri="{FF2B5EF4-FFF2-40B4-BE49-F238E27FC236}">
                <a16:creationId xmlns:a16="http://schemas.microsoft.com/office/drawing/2014/main" id="{3C267A17-B150-B34D-93D4-CF0A5D3FB84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484950" y="1208831"/>
            <a:ext cx="3228707" cy="3228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8967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4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8</TotalTime>
  <Words>224</Words>
  <Application>Microsoft Macintosh PowerPoint</Application>
  <PresentationFormat>画面に合わせる (4:3)</PresentationFormat>
  <Paragraphs>24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15:44:26Z</dcterms:modified>
</cp:coreProperties>
</file>